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1"/>
  </p:notesMasterIdLst>
  <p:sldIdLst>
    <p:sldId id="298" r:id="rId2"/>
    <p:sldId id="256" r:id="rId3"/>
    <p:sldId id="257" r:id="rId4"/>
    <p:sldId id="258" r:id="rId5"/>
    <p:sldId id="259" r:id="rId6"/>
    <p:sldId id="260" r:id="rId7"/>
    <p:sldId id="261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8" r:id="rId22"/>
    <p:sldId id="276" r:id="rId23"/>
    <p:sldId id="277" r:id="rId24"/>
    <p:sldId id="282" r:id="rId25"/>
    <p:sldId id="296" r:id="rId26"/>
    <p:sldId id="289" r:id="rId27"/>
    <p:sldId id="297" r:id="rId28"/>
    <p:sldId id="291" r:id="rId29"/>
    <p:sldId id="293" r:id="rId30"/>
  </p:sldIdLst>
  <p:sldSz cx="12192000" cy="6858000"/>
  <p:notesSz cx="6858000" cy="9144000"/>
  <p:defaultTextStyle>
    <a:defPPr>
      <a:defRPr lang="en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9EAEBB9-FFCA-92B4-8C68-477070D1BA16}" name="Xiongyu Wu" initials="XW" userId="S::xiowu62@liu.se::0f7ea6f7-9ed0-4b2e-b744-d5e5888ae87c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361" autoAdjust="0"/>
    <p:restoredTop sz="94660"/>
  </p:normalViewPr>
  <p:slideViewPr>
    <p:cSldViewPr snapToGrid="0">
      <p:cViewPr varScale="1">
        <p:scale>
          <a:sx n="86" d="100"/>
          <a:sy n="86" d="100"/>
        </p:scale>
        <p:origin x="96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microsoft.com/office/2018/10/relationships/authors" Target="author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747504-8ED0-4DBC-B4FE-67D0453F52E8}" type="datetimeFigureOut">
              <a:rPr lang="en-US" smtClean="0"/>
              <a:t>6/2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9E37DE-D3E2-4CF5-B1A2-92CB8383C2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0767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9E37DE-D3E2-4CF5-B1A2-92CB8383C200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34967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9E37DE-D3E2-4CF5-B1A2-92CB8383C200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55278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9E37DE-D3E2-4CF5-B1A2-92CB8383C200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26341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9E37DE-D3E2-4CF5-B1A2-92CB8383C200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4266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3F68CC-8AAF-4A3F-BC00-F225ECD4E7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0CD2185-4E6E-4C7F-B0BD-EE51BC400B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8F5EEC-E4F2-4769-98C8-DDDF798119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A4E7A-F9DC-4E3A-84DB-3647A81A3C22}" type="datetimeFigureOut">
              <a:rPr lang="en-SE" smtClean="0"/>
              <a:t>06/28/2024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8D55EB-9905-432D-A072-43ECC2928F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FC129E-0937-43F7-8C9D-6B6EAFDA2E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D0D3-EFB6-4E02-87AB-7C8EA23B2A83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5741193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871F62-4BA6-45E5-A4FE-ABB2DA4E27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4F5961F-88F0-42CA-941A-742119FF25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DD1F45-3E9B-4F4E-A0C3-B520C760A2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A4E7A-F9DC-4E3A-84DB-3647A81A3C22}" type="datetimeFigureOut">
              <a:rPr lang="en-SE" smtClean="0"/>
              <a:t>06/28/2024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C1C971-3FBB-4513-B2FA-5F83752E2A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42E8A6-EC02-400F-9AB1-22FDE4A3A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D0D3-EFB6-4E02-87AB-7C8EA23B2A83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6508672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9CEC8DD-34C6-46E3-8C52-2A71460FA9D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3CC1D58-208D-400C-BC5F-6B638AD546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014C8A-39F5-4349-8172-0EB8641DFC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A4E7A-F9DC-4E3A-84DB-3647A81A3C22}" type="datetimeFigureOut">
              <a:rPr lang="en-SE" smtClean="0"/>
              <a:t>06/28/2024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F71E98-6E34-44A7-8BD8-8AFF639BEB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F0DA59-EEEB-4F66-BA8E-0ECAC3DBA1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D0D3-EFB6-4E02-87AB-7C8EA23B2A83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511160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AB5666-889F-4F6A-8A06-117B035B18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6C4C00-E9E2-404C-9780-1C1F05E0A6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10BE11-1DAE-4EDB-8817-B7A46CEBDC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A4E7A-F9DC-4E3A-84DB-3647A81A3C22}" type="datetimeFigureOut">
              <a:rPr lang="en-SE" smtClean="0"/>
              <a:t>06/28/2024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1642D4-6F7C-4096-8A27-4E03CA2BE6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8FDB93-62F8-43D4-9502-E334FA9CF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D0D3-EFB6-4E02-87AB-7C8EA23B2A83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9533814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0EDEDF-1D24-433A-8C3F-697C271D5B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8E45A2-3B49-4B79-AAA5-26FACB4A50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4FC770-55EC-420B-A779-B27649FDBF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A4E7A-F9DC-4E3A-84DB-3647A81A3C22}" type="datetimeFigureOut">
              <a:rPr lang="en-SE" smtClean="0"/>
              <a:t>06/28/2024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55BB1D-AC18-4D6B-B493-531A0E9794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C9A8BD-FEA5-499D-B45A-BB6DF28558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D0D3-EFB6-4E02-87AB-7C8EA23B2A83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4130446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7EB728-763E-4564-982B-B1653ED482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7071F7-8C5B-42A7-A309-F61C40529C7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15086C-1592-4945-9F0B-DCA446AA44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F4B636-6D9B-4738-BA5A-603CF9BA3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A4E7A-F9DC-4E3A-84DB-3647A81A3C22}" type="datetimeFigureOut">
              <a:rPr lang="en-SE" smtClean="0"/>
              <a:t>06/28/2024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BEAC94-E4F7-4035-93DE-FAB6613D1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C1A9FC-BAFD-4975-9438-FAF72485E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D0D3-EFB6-4E02-87AB-7C8EA23B2A83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2806149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2E36D8-E63B-43BA-BA14-BB8F8AB7B7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5E8869-5DBD-411D-90CF-17D686D3C9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9CD7E06-3366-4207-AA1B-9931E03E18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DFA9936-3854-46F3-9527-307049FF04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5212715-9551-4CC2-B921-DE09D29294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83D3AFB-F557-45A7-BAA3-281E6DAEB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A4E7A-F9DC-4E3A-84DB-3647A81A3C22}" type="datetimeFigureOut">
              <a:rPr lang="en-SE" smtClean="0"/>
              <a:t>06/28/2024</a:t>
            </a:fld>
            <a:endParaRPr lang="en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3333C71-7971-42E4-8B4D-8CD6B7CE95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6C9AB86-DFED-4C00-8A76-DEEB7D0255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D0D3-EFB6-4E02-87AB-7C8EA23B2A83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0128910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04BFD6-DBD7-4473-81E4-5E39229B4C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49761D5-D835-4A20-B413-9F0A12ABFC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A4E7A-F9DC-4E3A-84DB-3647A81A3C22}" type="datetimeFigureOut">
              <a:rPr lang="en-SE" smtClean="0"/>
              <a:t>06/28/2024</a:t>
            </a:fld>
            <a:endParaRPr lang="en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77F1619-C3F6-4F59-8E22-AB535C3428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9CB91AA-0A46-4BD6-8F3D-2823B9024A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D0D3-EFB6-4E02-87AB-7C8EA23B2A83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2598710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6484335-F9E6-460D-BA83-8183EBBA1A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A4E7A-F9DC-4E3A-84DB-3647A81A3C22}" type="datetimeFigureOut">
              <a:rPr lang="en-SE" smtClean="0"/>
              <a:t>06/28/2024</a:t>
            </a:fld>
            <a:endParaRPr lang="en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68D6E22-2B5D-4733-8034-D2E12E424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43EC804-05DD-4FD8-91D3-22E2B0BB8C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D0D3-EFB6-4E02-87AB-7C8EA23B2A83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4627190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B22B29-4322-4598-9331-4237D1C96B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0715BD-A1C0-4834-B4EF-EF3AE7F195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9E58BC-65BB-4B97-A344-30F05148B8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BF7F29-66C9-4931-9251-58EC24F445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A4E7A-F9DC-4E3A-84DB-3647A81A3C22}" type="datetimeFigureOut">
              <a:rPr lang="en-SE" smtClean="0"/>
              <a:t>06/28/2024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0746EE-DC41-44C0-9A4E-7D2A17959E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5DD62E-E059-4CB2-8FD9-B508B7D2D3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D0D3-EFB6-4E02-87AB-7C8EA23B2A83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597692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7E907E-8499-48EC-B8AF-F49BB0D248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FDE5049-14DF-4026-A83D-464B9694F7B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BEB955-412F-4F0C-B37A-91F40AAE6D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884B3C-F628-47EF-A70F-A2A42655E3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A4E7A-F9DC-4E3A-84DB-3647A81A3C22}" type="datetimeFigureOut">
              <a:rPr lang="en-SE" smtClean="0"/>
              <a:t>06/28/2024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637F1D-0192-411C-AC86-5325EA009D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6CDE83-9A36-438E-A97F-2C0ECB44AC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1D0D3-EFB6-4E02-87AB-7C8EA23B2A83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1070946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36B9973-7F7E-48ED-BABE-A4AB4F9178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B446C6-5436-483C-A6B4-015A9E6860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B4B224-FD1D-40A9-8587-54EACA09FA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1A4E7A-F9DC-4E3A-84DB-3647A81A3C22}" type="datetimeFigureOut">
              <a:rPr lang="en-SE" smtClean="0"/>
              <a:t>06/28/2024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6B0245-B9D9-4FA6-A416-101CC0BFD1F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A9FE50-7C5E-4F1F-B857-EB6BE08822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F1D0D3-EFB6-4E02-87AB-7C8EA23B2A83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0485504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jpeg"/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jpeg"/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297E2A0-2104-D877-2AD3-717BBE57697A}"/>
              </a:ext>
            </a:extLst>
          </p:cNvPr>
          <p:cNvSpPr txBox="1"/>
          <p:nvPr/>
        </p:nvSpPr>
        <p:spPr>
          <a:xfrm>
            <a:off x="1115962" y="1204641"/>
            <a:ext cx="9960076" cy="13603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Bef>
                <a:spcPts val="1200"/>
              </a:spcBef>
              <a:spcAft>
                <a:spcPts val="800"/>
              </a:spcAft>
            </a:pPr>
            <a:r>
              <a:rPr lang="en-US" sz="2000" kern="100" dirty="0">
                <a:effectLst/>
                <a:latin typeface="Times New Roman" panose="02020603050405020304" pitchFamily="18" charset="0"/>
                <a:ea typeface="DengXian Light" panose="02010600030101010101" pitchFamily="2" charset="-122"/>
                <a:cs typeface="Times New Roman" panose="02020603050405020304" pitchFamily="18" charset="0"/>
              </a:rPr>
              <a:t>Supporting information</a:t>
            </a:r>
            <a:endParaRPr lang="en-US" sz="2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Bef>
                <a:spcPts val="1200"/>
              </a:spcBef>
              <a:spcAft>
                <a:spcPts val="800"/>
              </a:spcAft>
            </a:pPr>
            <a:r>
              <a:rPr lang="en-US" sz="1800" kern="100" dirty="0">
                <a:effectLst/>
                <a:latin typeface="Times New Roman" panose="02020603050405020304" pitchFamily="18" charset="0"/>
                <a:ea typeface="DengXian Light" panose="02010600030101010101" pitchFamily="2" charset="-122"/>
                <a:cs typeface="Times New Roman" panose="02020603050405020304" pitchFamily="18" charset="0"/>
              </a:rPr>
              <a:t>MSMS spectra</a:t>
            </a:r>
            <a:endParaRPr lang="en-US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0840009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30A26DAE-157D-BBDF-1823-7889DDE580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6901" y="265631"/>
            <a:ext cx="10278198" cy="63267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374843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2EDAF535-F2D8-B9C3-7BF7-76D04B5A859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6990" y="354022"/>
            <a:ext cx="9738019" cy="61499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030516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917565CA-7098-FB80-D60F-F6505B509E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5886" y="269869"/>
            <a:ext cx="10180227" cy="61476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597232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FF7AA7C6-D97A-BA5C-7C3C-57D89CE2ED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2194" y="276504"/>
            <a:ext cx="9787611" cy="63049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864741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8BC74C0D-D2F8-0EE2-E5A0-59BCBC32A1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6858" y="279754"/>
            <a:ext cx="10618284" cy="62984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473827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E0F054C4-B3D4-61B2-A2F3-24D94DCC32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5820" y="552078"/>
            <a:ext cx="9580360" cy="57538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476220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FA3B70F6-E8A1-9DA3-4F16-74C5898D1ED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6238" y="469791"/>
            <a:ext cx="9359523" cy="59184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62995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6D0D805F-752C-E3B9-D201-CE69AB23DA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8098" y="408320"/>
            <a:ext cx="9555803" cy="60413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542389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7452E2F6-E179-3267-49C3-A2FDE29630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9564" y="347360"/>
            <a:ext cx="10792872" cy="61632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288313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90E2DB43-95B8-BEC7-1892-138A2E44EA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9726" y="506518"/>
            <a:ext cx="9692547" cy="58449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62476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866D56A2-28A5-5F42-781B-1735BD566A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6840" y="285750"/>
            <a:ext cx="9418320" cy="6286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69727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FA1E5E5C-C79D-3622-09D8-E4EBEE64AE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8286" y="478217"/>
            <a:ext cx="9695428" cy="59015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794719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65406F40-963A-65BB-FA4C-A329140A2A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1347" y="432806"/>
            <a:ext cx="9849305" cy="59923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144695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C26B3279-2A6E-5318-7F56-A4436AC992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6008" y="433643"/>
            <a:ext cx="9939983" cy="59907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803717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74A02973-F6A9-F9D7-77A8-1D8007D198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0083" y="448279"/>
            <a:ext cx="9711833" cy="59614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1464984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C92C10F-2D0B-D230-566A-1ADB29E062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2888" y="1590161"/>
            <a:ext cx="10586224" cy="30470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2623191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F94D1F9-50BB-68B0-5233-35D20A469A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4897" y="1812043"/>
            <a:ext cx="11322205" cy="32339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05094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3D4E053-4798-B931-62C8-861DA432FD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3927" y="1799262"/>
            <a:ext cx="11244146" cy="32594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2987052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7E19FF5-9757-BB50-1D4C-9985AFB55E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4048" y="1899721"/>
            <a:ext cx="10943903" cy="30585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579328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5E331C4-41D6-3E54-930F-CA8BEB93EF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6381" y="602166"/>
            <a:ext cx="11395619" cy="51912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5708946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3E6DE1A-3EF0-6074-0BC9-33E7C044A1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1737" y="1871050"/>
            <a:ext cx="11400263" cy="28691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91268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B284F8C6-986B-224D-F4AB-BC8E7C91E3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9388" y="427334"/>
            <a:ext cx="10793223" cy="60033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34155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3BE6D72-E39F-539B-8B6B-3322425546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8949" y="452646"/>
            <a:ext cx="10854101" cy="59527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5731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27FD679-DEEA-5000-208B-36C4B9B43C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5032" y="353633"/>
            <a:ext cx="10301936" cy="61507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97862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2BF2E9E-5B82-C039-065A-04009A33C6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2803" y="400282"/>
            <a:ext cx="10946394" cy="60574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2792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598FC682-23DB-83E1-1706-F67E5A46C4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2155" y="483545"/>
            <a:ext cx="10687690" cy="58909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539469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49B5BA14-2548-A296-7F5C-CBCB8DDE46B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6515" y="479409"/>
            <a:ext cx="9758970" cy="5899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657279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09AA3F8E-5F38-B5C3-0B0F-D8F87BCB45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2713" y="379327"/>
            <a:ext cx="10146574" cy="60993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26659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515</TotalTime>
  <Words>8</Words>
  <Application>Microsoft Office PowerPoint</Application>
  <PresentationFormat>Widescreen</PresentationFormat>
  <Paragraphs>6</Paragraphs>
  <Slides>29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9</vt:i4>
      </vt:variant>
    </vt:vector>
  </HeadingPairs>
  <TitlesOfParts>
    <vt:vector size="35" baseType="lpstr">
      <vt:lpstr>Aptos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1</dc:creator>
  <cp:lastModifiedBy>Tobias Rautio</cp:lastModifiedBy>
  <cp:revision>48</cp:revision>
  <dcterms:created xsi:type="dcterms:W3CDTF">2023-10-25T07:05:57Z</dcterms:created>
  <dcterms:modified xsi:type="dcterms:W3CDTF">2024-06-28T11:55:24Z</dcterms:modified>
</cp:coreProperties>
</file>